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345" r:id="rId5"/>
  </p:sldIdLst>
  <p:sldSz cx="12192000" cy="6858000"/>
  <p:notesSz cx="7099300" cy="93853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ooyun" initials="B" lastIdx="18" clrIdx="0">
    <p:extLst>
      <p:ext uri="{19B8F6BF-5375-455C-9EA6-DF929625EA0E}">
        <p15:presenceInfo xmlns:p15="http://schemas.microsoft.com/office/powerpoint/2012/main" userId="Jooyu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897" autoAdjust="0"/>
    <p:restoredTop sz="94004" autoAdjust="0"/>
  </p:normalViewPr>
  <p:slideViewPr>
    <p:cSldViewPr snapToGrid="0">
      <p:cViewPr varScale="1">
        <p:scale>
          <a:sx n="100" d="100"/>
          <a:sy n="100" d="100"/>
        </p:scale>
        <p:origin x="1260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commentAuthors" Target="comment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3077006" cy="471188"/>
          </a:xfrm>
          <a:prstGeom prst="rect">
            <a:avLst/>
          </a:prstGeom>
        </p:spPr>
        <p:txBody>
          <a:bodyPr vert="horz" lIns="92437" tIns="46218" rIns="92437" bIns="46218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0687" y="1"/>
            <a:ext cx="3077006" cy="471188"/>
          </a:xfrm>
          <a:prstGeom prst="rect">
            <a:avLst/>
          </a:prstGeom>
        </p:spPr>
        <p:txBody>
          <a:bodyPr vert="horz" lIns="92437" tIns="46218" rIns="92437" bIns="46218" rtlCol="0"/>
          <a:lstStyle>
            <a:lvl1pPr algn="r">
              <a:defRPr sz="1200"/>
            </a:lvl1pPr>
          </a:lstStyle>
          <a:p>
            <a:fld id="{C566DA35-99F6-4000-9D74-43BC86A86EB4}" type="datetimeFigureOut">
              <a:rPr lang="en-US" smtClean="0"/>
              <a:t>11/10/2024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35013" y="1173163"/>
            <a:ext cx="5629275" cy="31670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37" tIns="46218" rIns="92437" bIns="46218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573" y="4516356"/>
            <a:ext cx="5678154" cy="3695782"/>
          </a:xfrm>
          <a:prstGeom prst="rect">
            <a:avLst/>
          </a:prstGeom>
        </p:spPr>
        <p:txBody>
          <a:bodyPr vert="horz" lIns="92437" tIns="46218" rIns="92437" bIns="46218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914112"/>
            <a:ext cx="3077006" cy="471188"/>
          </a:xfrm>
          <a:prstGeom prst="rect">
            <a:avLst/>
          </a:prstGeom>
        </p:spPr>
        <p:txBody>
          <a:bodyPr vert="horz" lIns="92437" tIns="46218" rIns="92437" bIns="46218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0687" y="8914112"/>
            <a:ext cx="3077006" cy="471188"/>
          </a:xfrm>
          <a:prstGeom prst="rect">
            <a:avLst/>
          </a:prstGeom>
        </p:spPr>
        <p:txBody>
          <a:bodyPr vert="horz" lIns="92437" tIns="46218" rIns="92437" bIns="46218" rtlCol="0" anchor="b"/>
          <a:lstStyle>
            <a:lvl1pPr algn="r">
              <a:defRPr sz="1200"/>
            </a:lvl1pPr>
          </a:lstStyle>
          <a:p>
            <a:fld id="{83825681-95D5-4F4F-B706-23D630D60451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880483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3825681-95D5-4F4F-B706-23D630D60451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967000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2F7DF-F4B6-4D27-875F-A91249D1D897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26503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086CA-2504-4DC5-9AA8-360C101BFA4A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951584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9CBE2A-CA65-432F-B39E-6BE1012C3AD5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970918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CC468-719C-45E6-9651-86EE7BB74CCD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886470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261A31-E71C-46E9-815E-037E5A45EC26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158423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ECB412-ABCB-4B5F-ACB6-42E1D6C2CD5A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30951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F87D8-3506-4D7A-9B56-CF00EE3F4E80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28633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ACC2AF-7287-47D5-9EBE-91894B4C09F4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513243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79E61-3DB6-4BB8-B07A-61A55F1BCEBF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796412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3F5209-8CCC-438A-AD8E-713D8519690E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482718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B939DC-3D29-4751-9602-80C8C0CB46DD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55606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DBC98A-7C6E-4F3C-811A-C11B3D3A9A34}" type="datetime1">
              <a:rPr lang="en-US" smtClean="0"/>
              <a:t>11/10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B9683B-5A87-43E7-A56C-ECDE7485FEA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581064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5569974"/>
              </p:ext>
            </p:extLst>
          </p:nvPr>
        </p:nvGraphicFramePr>
        <p:xfrm>
          <a:off x="2742661" y="3058510"/>
          <a:ext cx="6149092" cy="2712409"/>
        </p:xfrm>
        <a:graphic>
          <a:graphicData uri="http://schemas.openxmlformats.org/drawingml/2006/table">
            <a:tbl>
              <a:tblPr firstRow="1" firstCol="1" lastRow="1" lastCol="1" bandRow="1" bandCol="1"/>
              <a:tblGrid>
                <a:gridCol w="1440117">
                  <a:extLst>
                    <a:ext uri="{9D8B030D-6E8A-4147-A177-3AD203B41FA5}">
                      <a16:colId xmlns:a16="http://schemas.microsoft.com/office/drawing/2014/main" val="2745842127"/>
                    </a:ext>
                  </a:extLst>
                </a:gridCol>
                <a:gridCol w="1630739">
                  <a:extLst>
                    <a:ext uri="{9D8B030D-6E8A-4147-A177-3AD203B41FA5}">
                      <a16:colId xmlns:a16="http://schemas.microsoft.com/office/drawing/2014/main" val="241993716"/>
                    </a:ext>
                  </a:extLst>
                </a:gridCol>
                <a:gridCol w="1275322">
                  <a:extLst>
                    <a:ext uri="{9D8B030D-6E8A-4147-A177-3AD203B41FA5}">
                      <a16:colId xmlns:a16="http://schemas.microsoft.com/office/drawing/2014/main" val="185360627"/>
                    </a:ext>
                  </a:extLst>
                </a:gridCol>
                <a:gridCol w="928513">
                  <a:extLst>
                    <a:ext uri="{9D8B030D-6E8A-4147-A177-3AD203B41FA5}">
                      <a16:colId xmlns:a16="http://schemas.microsoft.com/office/drawing/2014/main" val="65628232"/>
                    </a:ext>
                  </a:extLst>
                </a:gridCol>
                <a:gridCol w="874401">
                  <a:extLst>
                    <a:ext uri="{9D8B030D-6E8A-4147-A177-3AD203B41FA5}">
                      <a16:colId xmlns:a16="http://schemas.microsoft.com/office/drawing/2014/main" val="3047594698"/>
                    </a:ext>
                  </a:extLst>
                </a:gridCol>
              </a:tblGrid>
              <a:tr h="370412"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Samples</a:t>
                      </a:r>
                      <a:endParaRPr lang="en-US" sz="1200" kern="100" dirty="0">
                        <a:effectLst/>
                        <a:latin typeface="Arial" panose="020B0604020202020204" pitchFamily="34" charset="0"/>
                        <a:ea typeface="Dotum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200" b="1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AUC</a:t>
                      </a:r>
                      <a:r>
                        <a:rPr lang="de-DE" sz="1200" b="1" kern="100" baseline="-250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last</a:t>
                      </a:r>
                      <a:endParaRPr lang="en-US" sz="1200" kern="100" dirty="0">
                        <a:effectLst/>
                        <a:latin typeface="Arial" panose="020B0604020202020204" pitchFamily="34" charset="0"/>
                        <a:ea typeface="Dotum"/>
                        <a:cs typeface="Arial" panose="020B0604020202020204" pitchFamily="34" charset="0"/>
                      </a:endParaRPr>
                    </a:p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200" b="1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200" b="1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μ</a:t>
                      </a:r>
                      <a:r>
                        <a:rPr lang="de-DE" sz="1200" b="1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g*hr/mL, </a:t>
                      </a:r>
                      <a:r>
                        <a:rPr lang="en-US" sz="1200" b="1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μ</a:t>
                      </a:r>
                      <a:r>
                        <a:rPr lang="de-DE" sz="1200" b="1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g*hr/g)</a:t>
                      </a:r>
                      <a:endParaRPr lang="en-US" sz="1200" kern="100" dirty="0">
                        <a:effectLst/>
                        <a:latin typeface="Arial" panose="020B0604020202020204" pitchFamily="34" charset="0"/>
                        <a:ea typeface="Dotum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C</a:t>
                      </a:r>
                      <a:r>
                        <a:rPr lang="en-US" sz="1200" b="1" kern="100" baseline="-250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max</a:t>
                      </a:r>
                      <a:endParaRPr lang="en-US" sz="1200" kern="100" dirty="0">
                        <a:effectLst/>
                        <a:latin typeface="Arial" panose="020B0604020202020204" pitchFamily="34" charset="0"/>
                        <a:ea typeface="Dotum"/>
                        <a:cs typeface="Arial" panose="020B0604020202020204" pitchFamily="34" charset="0"/>
                      </a:endParaRPr>
                    </a:p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(ng/mL, ng/g)</a:t>
                      </a:r>
                      <a:endParaRPr lang="en-US" sz="1200" kern="100" dirty="0">
                        <a:effectLst/>
                        <a:latin typeface="Arial" panose="020B0604020202020204" pitchFamily="34" charset="0"/>
                        <a:ea typeface="Dotum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T</a:t>
                      </a:r>
                      <a:r>
                        <a:rPr lang="en-US" sz="1200" b="1" kern="100" baseline="-250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max</a:t>
                      </a:r>
                      <a:endParaRPr lang="en-US" sz="1200" kern="100" dirty="0">
                        <a:effectLst/>
                        <a:latin typeface="Arial" panose="020B0604020202020204" pitchFamily="34" charset="0"/>
                        <a:ea typeface="Dotum"/>
                        <a:cs typeface="Arial" panose="020B0604020202020204" pitchFamily="34" charset="0"/>
                      </a:endParaRPr>
                    </a:p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(hr)</a:t>
                      </a:r>
                      <a:endParaRPr lang="en-US" sz="1200" kern="100" dirty="0">
                        <a:effectLst/>
                        <a:latin typeface="Arial" panose="020B0604020202020204" pitchFamily="34" charset="0"/>
                        <a:ea typeface="Dotum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200" b="1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T/P</a:t>
                      </a:r>
                      <a:endParaRPr lang="en-US" sz="1200" kern="100" dirty="0">
                        <a:effectLst/>
                        <a:latin typeface="Arial" panose="020B0604020202020204" pitchFamily="34" charset="0"/>
                        <a:ea typeface="Dotum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8154320"/>
                  </a:ext>
                </a:extLst>
              </a:tr>
              <a:tr h="185206"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Plasma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5.6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489.7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4.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10599330"/>
                  </a:ext>
                </a:extLst>
              </a:tr>
              <a:tr h="185206"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Lung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119.7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9366.7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8.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21.3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1743805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Kidney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105.4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9383.3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8.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18.7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57349674"/>
                  </a:ext>
                </a:extLst>
              </a:tr>
              <a:tr h="185206"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Small intestine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86.2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9966.7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4.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15.3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21290479"/>
                  </a:ext>
                </a:extLst>
              </a:tr>
              <a:tr h="185206"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Liver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65.8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7350.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4.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11.7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60247159"/>
                  </a:ext>
                </a:extLst>
              </a:tr>
              <a:tr h="185206"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Stomach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41.2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5378.3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1.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7.3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16609057"/>
                  </a:ext>
                </a:extLst>
              </a:tr>
              <a:tr h="185206"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Pancreas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29.1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2255.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8.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5.2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64646809"/>
                  </a:ext>
                </a:extLst>
              </a:tr>
              <a:tr h="185206"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Large intestine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18.3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2026.7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4.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3.2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88650107"/>
                  </a:ext>
                </a:extLst>
              </a:tr>
              <a:tr h="185206"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Spleen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17.5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1256.7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8.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3.1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479125114"/>
                  </a:ext>
                </a:extLst>
              </a:tr>
              <a:tr h="185206"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Heart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5.9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528.7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4.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1.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07958570"/>
                  </a:ext>
                </a:extLst>
              </a:tr>
              <a:tr h="185206"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Bone marrow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1.9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220.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8.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0.3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67466578"/>
                  </a:ext>
                </a:extLst>
              </a:tr>
              <a:tr h="185206"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Brain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0.2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16.7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12.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 latinLnBrk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ea typeface="Dotum"/>
                          <a:cs typeface="Arial" panose="020B0604020202020204" pitchFamily="34" charset="0"/>
                        </a:rPr>
                        <a:t>0.03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08427613"/>
                  </a:ext>
                </a:extLst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590692" y="26573"/>
            <a:ext cx="5213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146189" y="1892"/>
            <a:ext cx="5213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86256478"/>
              </p:ext>
            </p:extLst>
          </p:nvPr>
        </p:nvGraphicFramePr>
        <p:xfrm>
          <a:off x="635000" y="390525"/>
          <a:ext cx="5503863" cy="2759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5311642" imgH="2668021" progId="Prism10.Document">
                  <p:embed/>
                </p:oleObj>
              </mc:Choice>
              <mc:Fallback>
                <p:oleObj name="Prism 10" r:id="rId3" imgW="5311642" imgH="2668021" progId="Prism10.Document">
                  <p:embed/>
                  <p:pic>
                    <p:nvPicPr>
                      <p:cNvPr id="13" name="Object 1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35000" y="390525"/>
                        <a:ext cx="5503863" cy="275907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9416010"/>
              </p:ext>
            </p:extLst>
          </p:nvPr>
        </p:nvGraphicFramePr>
        <p:xfrm>
          <a:off x="6491417" y="-54956"/>
          <a:ext cx="4453391" cy="33035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5970330" imgH="4612133" progId="Prism9.Document">
                  <p:embed/>
                </p:oleObj>
              </mc:Choice>
              <mc:Fallback>
                <p:oleObj name="Prism 9" r:id="rId5" imgW="5970330" imgH="4612133" progId="Prism9.Document">
                  <p:embed/>
                  <p:pic>
                    <p:nvPicPr>
                      <p:cNvPr id="15" name="Object 1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491417" y="-54956"/>
                        <a:ext cx="4453391" cy="3303523"/>
                      </a:xfrm>
                      <a:prstGeom prst="rect">
                        <a:avLst/>
                      </a:prstGeom>
                      <a:noFill/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Rectangle 15"/>
          <p:cNvSpPr/>
          <p:nvPr/>
        </p:nvSpPr>
        <p:spPr>
          <a:xfrm>
            <a:off x="8541470" y="397658"/>
            <a:ext cx="265604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200" kern="100" dirty="0">
                <a:latin typeface="Arial" panose="020B0604020202020204" pitchFamily="34" charset="0"/>
                <a:cs typeface="Arial" panose="020B0604020202020204" pitchFamily="34" charset="0"/>
              </a:rPr>
              <a:t>* Tissue/Plasma ratio of brain = 0.03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239475" y="2987182"/>
            <a:ext cx="5213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4" name="TextBox 13"/>
          <p:cNvSpPr txBox="1"/>
          <p:nvPr/>
        </p:nvSpPr>
        <p:spPr>
          <a:xfrm flipH="1">
            <a:off x="0" y="6043800"/>
            <a:ext cx="1197036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 Pharmacokinetics of TUS in mice given 10 mg/kg orally. (A) Plasma and organ concentrations as a function of time after TUS administration; (B) Ratio of plasma to tissue AUC for major organs; (C) Calculated pharmacokinetic parameters.  All analyses included data from 3 animals per data point.</a:t>
            </a:r>
          </a:p>
        </p:txBody>
      </p:sp>
    </p:spTree>
    <p:extLst>
      <p:ext uri="{BB962C8B-B14F-4D97-AF65-F5344CB8AC3E}">
        <p14:creationId xmlns:p14="http://schemas.microsoft.com/office/powerpoint/2010/main" val="36109774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1eb8aacd-6de6-48dd-a465-60e446a07be9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3BF0FD5EBD9504A812482EA04CA64D6" ma:contentTypeVersion="17" ma:contentTypeDescription="Create a new document." ma:contentTypeScope="" ma:versionID="b5d29a2a6ada9cabbda7093401d8a1c2">
  <xsd:schema xmlns:xsd="http://www.w3.org/2001/XMLSchema" xmlns:xs="http://www.w3.org/2001/XMLSchema" xmlns:p="http://schemas.microsoft.com/office/2006/metadata/properties" xmlns:ns3="1eb8aacd-6de6-48dd-a465-60e446a07be9" xmlns:ns4="6c7c6a8e-e82f-4f57-8bcf-9b09f3980523" targetNamespace="http://schemas.microsoft.com/office/2006/metadata/properties" ma:root="true" ma:fieldsID="477d2955dc7cb3e9e420f794f0571505" ns3:_="" ns4:_="">
    <xsd:import namespace="1eb8aacd-6de6-48dd-a465-60e446a07be9"/>
    <xsd:import namespace="6c7c6a8e-e82f-4f57-8bcf-9b09f3980523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4:SharedWithUsers" minOccurs="0"/>
                <xsd:element ref="ns4:SharedWithDetails" minOccurs="0"/>
                <xsd:element ref="ns4:SharingHintHash" minOccurs="0"/>
                <xsd:element ref="ns3:MediaLengthInSeconds" minOccurs="0"/>
                <xsd:element ref="ns3:_activity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eb8aacd-6de6-48dd-a465-60e446a07be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4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5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20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1" nillable="true" ma:displayName="_activity" ma:hidden="true" ma:internalName="_activity">
      <xsd:simpleType>
        <xsd:restriction base="dms:Note"/>
      </xsd:simpleType>
    </xsd:element>
    <xsd:element name="MediaServiceObjectDetectorVersions" ma:index="2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23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c7c6a8e-e82f-4f57-8bcf-9b09f3980523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9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A905AD6D-FFB3-46D6-862B-6DD0C5991E72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897F8308-BB12-4A2F-8FC0-9231D37CE5BB}">
  <ds:schemaRefs>
    <ds:schemaRef ds:uri="http://purl.org/dc/terms/"/>
    <ds:schemaRef ds:uri="http://schemas.openxmlformats.org/package/2006/metadata/core-properties"/>
    <ds:schemaRef ds:uri="1eb8aacd-6de6-48dd-a465-60e446a07be9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6c7c6a8e-e82f-4f57-8bcf-9b09f3980523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D80DE6A3-5255-4AA5-B6DF-0755F693D23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eb8aacd-6de6-48dd-a465-60e446a07be9"/>
    <ds:schemaRef ds:uri="6c7c6a8e-e82f-4f57-8bcf-9b09f398052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4839</TotalTime>
  <Words>173</Words>
  <Application>Microsoft Office PowerPoint</Application>
  <PresentationFormat>Widescreen</PresentationFormat>
  <Paragraphs>74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ism 10</vt:lpstr>
      <vt:lpstr>Prism 9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nowal, Himangshu</dc:creator>
  <cp:lastModifiedBy>Himangshu Sonowal</cp:lastModifiedBy>
  <cp:revision>819</cp:revision>
  <cp:lastPrinted>2024-09-20T16:49:30Z</cp:lastPrinted>
  <dcterms:created xsi:type="dcterms:W3CDTF">2023-07-11T20:23:00Z</dcterms:created>
  <dcterms:modified xsi:type="dcterms:W3CDTF">2024-11-11T03:11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3BF0FD5EBD9504A812482EA04CA64D6</vt:lpwstr>
  </property>
</Properties>
</file>